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87" r:id="rId2"/>
    <p:sldId id="286" r:id="rId3"/>
    <p:sldId id="288" r:id="rId4"/>
  </p:sldIdLst>
  <p:sldSz cx="6858000" cy="9906000" type="A4"/>
  <p:notesSz cx="6797675" cy="992822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006" autoAdjust="0"/>
    <p:restoredTop sz="94660"/>
  </p:normalViewPr>
  <p:slideViewPr>
    <p:cSldViewPr snapToGrid="0">
      <p:cViewPr varScale="1">
        <p:scale>
          <a:sx n="70" d="100"/>
          <a:sy n="70" d="100"/>
        </p:scale>
        <p:origin x="1800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35EBA-10AF-4C8E-8916-CB24C3D2AA5E}" type="datetimeFigureOut">
              <a:rPr lang="en-US" smtClean="0"/>
              <a:t>6/18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8BD38A-7F91-4B3A-A9B3-752B930091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42858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35EBA-10AF-4C8E-8916-CB24C3D2AA5E}" type="datetimeFigureOut">
              <a:rPr lang="en-US" smtClean="0"/>
              <a:t>6/18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8BD38A-7F91-4B3A-A9B3-752B930091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58677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35EBA-10AF-4C8E-8916-CB24C3D2AA5E}" type="datetimeFigureOut">
              <a:rPr lang="en-US" smtClean="0"/>
              <a:t>6/18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8BD38A-7F91-4B3A-A9B3-752B930091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49660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35EBA-10AF-4C8E-8916-CB24C3D2AA5E}" type="datetimeFigureOut">
              <a:rPr lang="en-US" smtClean="0"/>
              <a:t>6/18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8BD38A-7F91-4B3A-A9B3-752B930091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27989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35EBA-10AF-4C8E-8916-CB24C3D2AA5E}" type="datetimeFigureOut">
              <a:rPr lang="en-US" smtClean="0"/>
              <a:t>6/18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8BD38A-7F91-4B3A-A9B3-752B930091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42746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35EBA-10AF-4C8E-8916-CB24C3D2AA5E}" type="datetimeFigureOut">
              <a:rPr lang="en-US" smtClean="0"/>
              <a:t>6/18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8BD38A-7F91-4B3A-A9B3-752B930091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24382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35EBA-10AF-4C8E-8916-CB24C3D2AA5E}" type="datetimeFigureOut">
              <a:rPr lang="en-US" smtClean="0"/>
              <a:t>6/18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8BD38A-7F91-4B3A-A9B3-752B930091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1766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35EBA-10AF-4C8E-8916-CB24C3D2AA5E}" type="datetimeFigureOut">
              <a:rPr lang="en-US" smtClean="0"/>
              <a:t>6/18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8BD38A-7F91-4B3A-A9B3-752B930091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62959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35EBA-10AF-4C8E-8916-CB24C3D2AA5E}" type="datetimeFigureOut">
              <a:rPr lang="en-US" smtClean="0"/>
              <a:t>6/18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8BD38A-7F91-4B3A-A9B3-752B930091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13043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35EBA-10AF-4C8E-8916-CB24C3D2AA5E}" type="datetimeFigureOut">
              <a:rPr lang="en-US" smtClean="0"/>
              <a:t>6/18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8BD38A-7F91-4B3A-A9B3-752B930091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45949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35EBA-10AF-4C8E-8916-CB24C3D2AA5E}" type="datetimeFigureOut">
              <a:rPr lang="en-US" smtClean="0"/>
              <a:t>6/18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8BD38A-7F91-4B3A-A9B3-752B930091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32087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235EBA-10AF-4C8E-8916-CB24C3D2AA5E}" type="datetimeFigureOut">
              <a:rPr lang="en-US" smtClean="0"/>
              <a:t>6/18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8BD38A-7F91-4B3A-A9B3-752B930091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32943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6BC98492-092E-478D-B178-CFA9366F007D}"/>
              </a:ext>
            </a:extLst>
          </p:cNvPr>
          <p:cNvSpPr txBox="1"/>
          <p:nvPr/>
        </p:nvSpPr>
        <p:spPr>
          <a:xfrm>
            <a:off x="108766" y="126292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dirty="0"/>
              <a:t>A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3F52C941-1862-4389-976D-9AC47BF13A38}"/>
              </a:ext>
            </a:extLst>
          </p:cNvPr>
          <p:cNvSpPr txBox="1"/>
          <p:nvPr/>
        </p:nvSpPr>
        <p:spPr>
          <a:xfrm>
            <a:off x="1632819" y="3409803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dirty="0"/>
              <a:t>C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DE2FA0A6-7142-43DA-B086-19D4E2DB2FBD}"/>
              </a:ext>
            </a:extLst>
          </p:cNvPr>
          <p:cNvSpPr txBox="1"/>
          <p:nvPr/>
        </p:nvSpPr>
        <p:spPr>
          <a:xfrm>
            <a:off x="3364982" y="126292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dirty="0"/>
              <a:t>B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28761A6F-4B61-4C67-B0DD-0C46F2D3D4FC}"/>
              </a:ext>
            </a:extLst>
          </p:cNvPr>
          <p:cNvSpPr txBox="1"/>
          <p:nvPr/>
        </p:nvSpPr>
        <p:spPr>
          <a:xfrm>
            <a:off x="182268" y="6764808"/>
            <a:ext cx="650680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: PCA plots of three validation sets showing the distribution of patients using 4 hub gene signatures. (A) GSE37250, (B) GSE39940, (C) GSE19439.</a:t>
            </a:r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B2E7B1FB-C400-4991-B703-4E6C7FBF6029}"/>
              </a:ext>
            </a:extLst>
          </p:cNvPr>
          <p:cNvGrpSpPr/>
          <p:nvPr/>
        </p:nvGrpSpPr>
        <p:grpSpPr>
          <a:xfrm>
            <a:off x="182269" y="506105"/>
            <a:ext cx="2446631" cy="2462494"/>
            <a:chOff x="182269" y="506105"/>
            <a:chExt cx="2446631" cy="2462494"/>
          </a:xfrm>
        </p:grpSpPr>
        <p:grpSp>
          <p:nvGrpSpPr>
            <p:cNvPr id="26" name="Group 25">
              <a:extLst>
                <a:ext uri="{FF2B5EF4-FFF2-40B4-BE49-F238E27FC236}">
                  <a16:creationId xmlns:a16="http://schemas.microsoft.com/office/drawing/2014/main" id="{59BF4580-566B-4A4D-8597-25938C763731}"/>
                </a:ext>
              </a:extLst>
            </p:cNvPr>
            <p:cNvGrpSpPr/>
            <p:nvPr/>
          </p:nvGrpSpPr>
          <p:grpSpPr>
            <a:xfrm>
              <a:off x="229933" y="506105"/>
              <a:ext cx="2398967" cy="2386348"/>
              <a:chOff x="229933" y="725180"/>
              <a:chExt cx="2398967" cy="2386348"/>
            </a:xfrm>
          </p:grpSpPr>
          <p:pic>
            <p:nvPicPr>
              <p:cNvPr id="11" name="Picture 10">
                <a:extLst>
                  <a:ext uri="{FF2B5EF4-FFF2-40B4-BE49-F238E27FC236}">
                    <a16:creationId xmlns:a16="http://schemas.microsoft.com/office/drawing/2014/main" id="{6A3B2934-40C9-427F-A8AD-EED787D71B8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6951" r="16851"/>
              <a:stretch/>
            </p:blipFill>
            <p:spPr>
              <a:xfrm>
                <a:off x="229933" y="725180"/>
                <a:ext cx="2398967" cy="2386348"/>
              </a:xfrm>
              <a:prstGeom prst="rect">
                <a:avLst/>
              </a:prstGeom>
            </p:spPr>
          </p:pic>
          <p:pic>
            <p:nvPicPr>
              <p:cNvPr id="21" name="Picture 20">
                <a:extLst>
                  <a:ext uri="{FF2B5EF4-FFF2-40B4-BE49-F238E27FC236}">
                    <a16:creationId xmlns:a16="http://schemas.microsoft.com/office/drawing/2014/main" id="{FC7DE9B6-B83E-4A1E-9567-8D105E922DE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3274" t="8792" r="7923" b="82047"/>
              <a:stretch/>
            </p:blipFill>
            <p:spPr>
              <a:xfrm>
                <a:off x="2133917" y="760041"/>
                <a:ext cx="447990" cy="414391"/>
              </a:xfrm>
              <a:prstGeom prst="rect">
                <a:avLst/>
              </a:prstGeom>
            </p:spPr>
          </p:pic>
        </p:grp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D95DC381-F0B2-46E9-A509-4163536EE12F}"/>
                </a:ext>
              </a:extLst>
            </p:cNvPr>
            <p:cNvSpPr txBox="1"/>
            <p:nvPr/>
          </p:nvSpPr>
          <p:spPr>
            <a:xfrm rot="16200000">
              <a:off x="-88800" y="1487330"/>
              <a:ext cx="772969" cy="2308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900" b="1" dirty="0"/>
                <a:t>PC 2 (25.8%)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85AA060F-FCD0-43B8-B928-5BD93157B51B}"/>
                </a:ext>
              </a:extLst>
            </p:cNvPr>
            <p:cNvSpPr txBox="1"/>
            <p:nvPr/>
          </p:nvSpPr>
          <p:spPr>
            <a:xfrm>
              <a:off x="1135155" y="2737767"/>
              <a:ext cx="772969" cy="2308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900" b="1" dirty="0"/>
                <a:t>PC 1 (58.8%)</a:t>
              </a:r>
            </a:p>
          </p:txBody>
        </p:sp>
      </p:grpSp>
      <p:grpSp>
        <p:nvGrpSpPr>
          <p:cNvPr id="35" name="Group 34">
            <a:extLst>
              <a:ext uri="{FF2B5EF4-FFF2-40B4-BE49-F238E27FC236}">
                <a16:creationId xmlns:a16="http://schemas.microsoft.com/office/drawing/2014/main" id="{94E5EC07-2C21-44D6-9C1C-621ADA46E523}"/>
              </a:ext>
            </a:extLst>
          </p:cNvPr>
          <p:cNvGrpSpPr/>
          <p:nvPr/>
        </p:nvGrpSpPr>
        <p:grpSpPr>
          <a:xfrm>
            <a:off x="3395752" y="506104"/>
            <a:ext cx="2538432" cy="2537473"/>
            <a:chOff x="3395752" y="506104"/>
            <a:chExt cx="2538432" cy="2537473"/>
          </a:xfrm>
        </p:grpSpPr>
        <p:grpSp>
          <p:nvGrpSpPr>
            <p:cNvPr id="24" name="Group 23">
              <a:extLst>
                <a:ext uri="{FF2B5EF4-FFF2-40B4-BE49-F238E27FC236}">
                  <a16:creationId xmlns:a16="http://schemas.microsoft.com/office/drawing/2014/main" id="{38B2AEA2-5F04-4604-A115-E2E135CAE7EF}"/>
                </a:ext>
              </a:extLst>
            </p:cNvPr>
            <p:cNvGrpSpPr/>
            <p:nvPr/>
          </p:nvGrpSpPr>
          <p:grpSpPr>
            <a:xfrm>
              <a:off x="3429000" y="506104"/>
              <a:ext cx="2505184" cy="2488771"/>
              <a:chOff x="3429000" y="725179"/>
              <a:chExt cx="2505184" cy="2488771"/>
            </a:xfrm>
          </p:grpSpPr>
          <p:pic>
            <p:nvPicPr>
              <p:cNvPr id="19" name="Picture 18">
                <a:extLst>
                  <a:ext uri="{FF2B5EF4-FFF2-40B4-BE49-F238E27FC236}">
                    <a16:creationId xmlns:a16="http://schemas.microsoft.com/office/drawing/2014/main" id="{C300C54A-6F75-4508-95C0-7CBCF4A1D28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6286" r="16149"/>
              <a:stretch/>
            </p:blipFill>
            <p:spPr>
              <a:xfrm>
                <a:off x="3429000" y="725179"/>
                <a:ext cx="2505184" cy="2488771"/>
              </a:xfrm>
              <a:prstGeom prst="rect">
                <a:avLst/>
              </a:prstGeom>
            </p:spPr>
          </p:pic>
          <p:pic>
            <p:nvPicPr>
              <p:cNvPr id="22" name="Picture 21">
                <a:extLst>
                  <a:ext uri="{FF2B5EF4-FFF2-40B4-BE49-F238E27FC236}">
                    <a16:creationId xmlns:a16="http://schemas.microsoft.com/office/drawing/2014/main" id="{13ACA9D7-3363-4C47-BC04-46EBCD9D482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3274" t="8792" r="7923" b="82047"/>
              <a:stretch/>
            </p:blipFill>
            <p:spPr>
              <a:xfrm>
                <a:off x="5418137" y="775281"/>
                <a:ext cx="447990" cy="414391"/>
              </a:xfrm>
              <a:prstGeom prst="rect">
                <a:avLst/>
              </a:prstGeom>
            </p:spPr>
          </p:pic>
        </p:grp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6907B9C0-BBCF-4B1F-A6E7-11865DC512F2}"/>
                </a:ext>
              </a:extLst>
            </p:cNvPr>
            <p:cNvSpPr txBox="1"/>
            <p:nvPr/>
          </p:nvSpPr>
          <p:spPr>
            <a:xfrm rot="16200000">
              <a:off x="3124683" y="1443026"/>
              <a:ext cx="772969" cy="2308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900" b="1" dirty="0"/>
                <a:t>PC 2 (29.3%)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A34AC1FD-0F99-4E43-95C3-C88457E19B62}"/>
                </a:ext>
              </a:extLst>
            </p:cNvPr>
            <p:cNvSpPr txBox="1"/>
            <p:nvPr/>
          </p:nvSpPr>
          <p:spPr>
            <a:xfrm>
              <a:off x="4500738" y="2812745"/>
              <a:ext cx="772969" cy="2308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900" b="1" dirty="0"/>
                <a:t>PC 1 (57.4%)</a:t>
              </a:r>
            </a:p>
          </p:txBody>
        </p:sp>
      </p:grpSp>
      <p:grpSp>
        <p:nvGrpSpPr>
          <p:cNvPr id="36" name="Group 35">
            <a:extLst>
              <a:ext uri="{FF2B5EF4-FFF2-40B4-BE49-F238E27FC236}">
                <a16:creationId xmlns:a16="http://schemas.microsoft.com/office/drawing/2014/main" id="{921CFCD5-2137-4095-8471-DEA2DD87A2F9}"/>
              </a:ext>
            </a:extLst>
          </p:cNvPr>
          <p:cNvGrpSpPr/>
          <p:nvPr/>
        </p:nvGrpSpPr>
        <p:grpSpPr>
          <a:xfrm>
            <a:off x="1792709" y="3767139"/>
            <a:ext cx="2587379" cy="2557603"/>
            <a:chOff x="1792709" y="3767139"/>
            <a:chExt cx="2587379" cy="2557603"/>
          </a:xfrm>
        </p:grpSpPr>
        <p:grpSp>
          <p:nvGrpSpPr>
            <p:cNvPr id="25" name="Group 24">
              <a:extLst>
                <a:ext uri="{FF2B5EF4-FFF2-40B4-BE49-F238E27FC236}">
                  <a16:creationId xmlns:a16="http://schemas.microsoft.com/office/drawing/2014/main" id="{74FC4B98-52B3-4D97-A2E4-C9C6988E989B}"/>
                </a:ext>
              </a:extLst>
            </p:cNvPr>
            <p:cNvGrpSpPr/>
            <p:nvPr/>
          </p:nvGrpSpPr>
          <p:grpSpPr>
            <a:xfrm>
              <a:off x="1838333" y="3767139"/>
              <a:ext cx="2541755" cy="2538482"/>
              <a:chOff x="1838333" y="3900489"/>
              <a:chExt cx="2541755" cy="2538482"/>
            </a:xfrm>
          </p:grpSpPr>
          <p:pic>
            <p:nvPicPr>
              <p:cNvPr id="15" name="Picture 14">
                <a:extLst>
                  <a:ext uri="{FF2B5EF4-FFF2-40B4-BE49-F238E27FC236}">
                    <a16:creationId xmlns:a16="http://schemas.microsoft.com/office/drawing/2014/main" id="{71AE0572-997E-4016-AD80-1A7E650A453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6720" r="16978"/>
              <a:stretch/>
            </p:blipFill>
            <p:spPr>
              <a:xfrm>
                <a:off x="1838333" y="3900489"/>
                <a:ext cx="2541755" cy="2538482"/>
              </a:xfrm>
              <a:prstGeom prst="rect">
                <a:avLst/>
              </a:prstGeom>
            </p:spPr>
          </p:pic>
          <p:pic>
            <p:nvPicPr>
              <p:cNvPr id="23" name="Picture 22">
                <a:extLst>
                  <a:ext uri="{FF2B5EF4-FFF2-40B4-BE49-F238E27FC236}">
                    <a16:creationId xmlns:a16="http://schemas.microsoft.com/office/drawing/2014/main" id="{D8F6AFDF-E8E8-43BA-BAD7-4BDB01365AB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3274" t="8792" r="7923" b="82047"/>
              <a:stretch/>
            </p:blipFill>
            <p:spPr>
              <a:xfrm>
                <a:off x="3886912" y="3937581"/>
                <a:ext cx="447990" cy="414391"/>
              </a:xfrm>
              <a:prstGeom prst="rect">
                <a:avLst/>
              </a:prstGeom>
            </p:spPr>
          </p:pic>
        </p:grp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78303C8D-5216-4DB6-B254-539840898010}"/>
                </a:ext>
              </a:extLst>
            </p:cNvPr>
            <p:cNvSpPr txBox="1"/>
            <p:nvPr/>
          </p:nvSpPr>
          <p:spPr>
            <a:xfrm rot="16200000">
              <a:off x="1521640" y="4820155"/>
              <a:ext cx="772969" cy="2308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900" b="1" dirty="0"/>
                <a:t>PC 2 (29.4%)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90848E42-1032-4930-A1B2-F44F48CE708B}"/>
                </a:ext>
              </a:extLst>
            </p:cNvPr>
            <p:cNvSpPr txBox="1"/>
            <p:nvPr/>
          </p:nvSpPr>
          <p:spPr>
            <a:xfrm>
              <a:off x="2892035" y="6093910"/>
              <a:ext cx="772969" cy="2308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900" b="1" dirty="0"/>
                <a:t>PC 1 (54.2%)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60698894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74FCFBC5-5293-4B41-AA44-406D941D22F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249" y="481391"/>
            <a:ext cx="6825751" cy="2055309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5DEC1879-9118-45CB-B7B2-EBB3BC1CD02F}"/>
              </a:ext>
            </a:extLst>
          </p:cNvPr>
          <p:cNvSpPr txBox="1"/>
          <p:nvPr/>
        </p:nvSpPr>
        <p:spPr>
          <a:xfrm>
            <a:off x="32249" y="180975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dirty="0"/>
              <a:t>A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F24BFCE1-363C-4D65-9448-935D869A286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5736766"/>
            <a:ext cx="6858000" cy="206502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F28B82E5-FBAA-4AD0-BACE-580090A4817E}"/>
              </a:ext>
            </a:extLst>
          </p:cNvPr>
          <p:cNvSpPr txBox="1"/>
          <p:nvPr/>
        </p:nvSpPr>
        <p:spPr>
          <a:xfrm>
            <a:off x="6601" y="5498024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dirty="0"/>
              <a:t>C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8AB9792B-55C3-4703-ADB9-2F228A842693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995967"/>
            <a:ext cx="6858000" cy="2095500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62B34567-2473-4B4F-BBC7-D5CB18E34256}"/>
              </a:ext>
            </a:extLst>
          </p:cNvPr>
          <p:cNvSpPr txBox="1"/>
          <p:nvPr/>
        </p:nvSpPr>
        <p:spPr>
          <a:xfrm>
            <a:off x="32249" y="2882749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dirty="0"/>
              <a:t>B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44BA3D34-6E0A-4296-8815-8D4F288660EA}"/>
              </a:ext>
            </a:extLst>
          </p:cNvPr>
          <p:cNvSpPr txBox="1"/>
          <p:nvPr/>
        </p:nvSpPr>
        <p:spPr>
          <a:xfrm>
            <a:off x="159848" y="8277808"/>
            <a:ext cx="651886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: Heatmaps of three validation sets showing the gene expression profiles of 4 hub genes signatures. (A) GSE37250, (B) GSE39940, (C) GSE19439.</a:t>
            </a:r>
          </a:p>
        </p:txBody>
      </p:sp>
    </p:spTree>
    <p:extLst>
      <p:ext uri="{BB962C8B-B14F-4D97-AF65-F5344CB8AC3E}">
        <p14:creationId xmlns:p14="http://schemas.microsoft.com/office/powerpoint/2010/main" val="4661271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301A89E8-5B44-46A7-A6EF-FF74D0C4686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0974" y="4105432"/>
            <a:ext cx="6570594" cy="2010115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ED2198BC-4F90-4945-93D4-C1CBA7695FCB}"/>
              </a:ext>
            </a:extLst>
          </p:cNvPr>
          <p:cNvSpPr txBox="1"/>
          <p:nvPr/>
        </p:nvSpPr>
        <p:spPr>
          <a:xfrm>
            <a:off x="214190" y="299277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dirty="0"/>
              <a:t>A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746BE9E4-66DE-4D59-9FCE-B1593FB62BF8}"/>
              </a:ext>
            </a:extLst>
          </p:cNvPr>
          <p:cNvSpPr txBox="1"/>
          <p:nvPr/>
        </p:nvSpPr>
        <p:spPr>
          <a:xfrm>
            <a:off x="170974" y="3621128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dirty="0"/>
              <a:t>B</a:t>
            </a: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2994255E-F611-4032-A6FC-45E6930ED0E9}"/>
              </a:ext>
            </a:extLst>
          </p:cNvPr>
          <p:cNvGrpSpPr/>
          <p:nvPr/>
        </p:nvGrpSpPr>
        <p:grpSpPr>
          <a:xfrm>
            <a:off x="336604" y="631957"/>
            <a:ext cx="2534325" cy="2553975"/>
            <a:chOff x="3356888" y="2911133"/>
            <a:chExt cx="2534325" cy="2553975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DFC8D5CC-042D-4C70-B696-A10EC026E65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83" t="6353" r="17301" b="1703"/>
            <a:stretch/>
          </p:blipFill>
          <p:spPr>
            <a:xfrm>
              <a:off x="3461414" y="2911133"/>
              <a:ext cx="2429799" cy="2469442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E9A51847-F15D-4EFF-8CCA-0E1BC929E31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4327" t="10858" r="4429" b="75311"/>
            <a:stretch/>
          </p:blipFill>
          <p:spPr>
            <a:xfrm>
              <a:off x="5361913" y="2960962"/>
              <a:ext cx="497723" cy="544238"/>
            </a:xfrm>
            <a:prstGeom prst="rect">
              <a:avLst/>
            </a:prstGeom>
          </p:spPr>
        </p:pic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3D263770-FA47-472E-B7FC-5474DBAEFE0E}"/>
                </a:ext>
              </a:extLst>
            </p:cNvPr>
            <p:cNvSpPr txBox="1"/>
            <p:nvPr/>
          </p:nvSpPr>
          <p:spPr>
            <a:xfrm rot="16200000">
              <a:off x="3085819" y="3924470"/>
              <a:ext cx="772969" cy="2308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900" b="1" dirty="0"/>
                <a:t>PC 2 (18.5%)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738CEF82-8DEA-4BFA-A84C-8890EF98F4EA}"/>
                </a:ext>
              </a:extLst>
            </p:cNvPr>
            <p:cNvSpPr txBox="1"/>
            <p:nvPr/>
          </p:nvSpPr>
          <p:spPr>
            <a:xfrm>
              <a:off x="4394051" y="5234276"/>
              <a:ext cx="772969" cy="2308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900" b="1" dirty="0"/>
                <a:t>PC 1 (43.5%)</a:t>
              </a:r>
            </a:p>
          </p:txBody>
        </p:sp>
      </p:grpSp>
      <p:sp>
        <p:nvSpPr>
          <p:cNvPr id="10" name="TextBox 9">
            <a:extLst>
              <a:ext uri="{FF2B5EF4-FFF2-40B4-BE49-F238E27FC236}">
                <a16:creationId xmlns:a16="http://schemas.microsoft.com/office/drawing/2014/main" id="{FB04404F-BE76-48BA-B7E8-F37DD7315819}"/>
              </a:ext>
            </a:extLst>
          </p:cNvPr>
          <p:cNvSpPr txBox="1"/>
          <p:nvPr/>
        </p:nvSpPr>
        <p:spPr>
          <a:xfrm>
            <a:off x="169568" y="6511827"/>
            <a:ext cx="651886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: PCA plot and heatmap of GSE31348 validation set showing the distribution of patients and the expression profiles of 4 </a:t>
            </a:r>
            <a:r>
              <a:rPr lang="en-US" sz="1400">
                <a:latin typeface="Times New Roman" panose="02020603050405020304" pitchFamily="18" charset="0"/>
                <a:cs typeface="Times New Roman" panose="02020603050405020304" pitchFamily="18" charset="0"/>
              </a:rPr>
              <a:t>hub genes signatures.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184106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8946</TotalTime>
  <Words>143</Words>
  <Application>Microsoft Office PowerPoint</Application>
  <PresentationFormat>A4 Paper (210x297 mm)</PresentationFormat>
  <Paragraphs>19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T</dc:creator>
  <cp:lastModifiedBy>IT</cp:lastModifiedBy>
  <cp:revision>793</cp:revision>
  <cp:lastPrinted>2025-04-10T01:25:53Z</cp:lastPrinted>
  <dcterms:created xsi:type="dcterms:W3CDTF">2024-04-22T02:20:04Z</dcterms:created>
  <dcterms:modified xsi:type="dcterms:W3CDTF">2025-06-18T03:59:35Z</dcterms:modified>
</cp:coreProperties>
</file>